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14AEE8-BB25-4B7B-85E1-251CE41F59A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9DB924-A70D-41E9-8343-891DBC0C7DE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479C53-9FDA-4713-8A0B-1A3E25E2419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A7A970-9975-44B2-89A1-E6EB578A74A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B54953-0CF6-488F-AC76-A9F758690CC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9BBC66-15A6-4BE9-B033-1AD336A832C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01E06F-6CA9-4CE8-BAAC-4028CC191F3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B45E40-3470-4B60-B48C-770C5BB9133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C1009F-B513-4D44-B8B6-2B53DA56EA2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CC75FB-1713-43D4-9D31-3944AA70A13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DA4C71-1FAA-41FC-899B-440C1EB728A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6405DE-0A73-4715-9190-C669AC65CF5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66A9B78-E917-47D7-99DF-48ECEED0330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3200400" y="2371680"/>
            <a:ext cx="1752480" cy="38088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4191120" y="2762280"/>
            <a:ext cx="2057400" cy="838080"/>
          </a:xfrm>
          <a:prstGeom prst="rect">
            <a:avLst/>
          </a:prstGeom>
          <a:solidFill>
            <a:srgbClr val="ccff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4067280" y="3600360"/>
            <a:ext cx="2181240" cy="333360"/>
          </a:xfrm>
          <a:prstGeom prst="rect">
            <a:avLst/>
          </a:prstGeom>
          <a:solidFill>
            <a:srgbClr val="ffcc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3276720" y="619200"/>
            <a:ext cx="1981080" cy="1752480"/>
          </a:xfrm>
          <a:prstGeom prst="rect">
            <a:avLst/>
          </a:prstGeom>
          <a:solidFill>
            <a:srgbClr val="ffff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1657440" y="85680"/>
            <a:ext cx="2152440" cy="571680"/>
          </a:xfrm>
          <a:prstGeom prst="rect">
            <a:avLst/>
          </a:prstGeom>
          <a:solidFill>
            <a:srgbClr val="bbe0e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6" name=""/>
          <p:cNvGrpSpPr/>
          <p:nvPr/>
        </p:nvGrpSpPr>
        <p:grpSpPr>
          <a:xfrm>
            <a:off x="29880" y="20520"/>
            <a:ext cx="6860160" cy="8954280"/>
            <a:chOff x="29880" y="20520"/>
            <a:chExt cx="6860160" cy="8954280"/>
          </a:xfrm>
        </p:grpSpPr>
        <p:sp>
          <p:nvSpPr>
            <p:cNvPr id="47" name=""/>
            <p:cNvSpPr/>
            <p:nvPr/>
          </p:nvSpPr>
          <p:spPr>
            <a:xfrm>
              <a:off x="347760" y="8902800"/>
              <a:ext cx="19512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405000" y="8748720"/>
              <a:ext cx="122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0.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 flipH="1">
              <a:off x="29880" y="84240"/>
              <a:ext cx="57150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5807880" y="20520"/>
              <a:ext cx="518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NC 006914.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 flipH="1">
              <a:off x="1819080" y="147600"/>
              <a:ext cx="5364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1933920" y="87480"/>
              <a:ext cx="146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ff0000"/>
                  </a:solidFill>
                  <a:latin typeface="Arial"/>
                </a:rPr>
                <a:t>16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 flipH="1">
              <a:off x="1819080" y="216000"/>
              <a:ext cx="522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1932480" y="152280"/>
              <a:ext cx="122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ff0000"/>
                  </a:solidFill>
                  <a:latin typeface="Arial"/>
                </a:rPr>
                <a:t>41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 flipH="1">
              <a:off x="1819080" y="279360"/>
              <a:ext cx="522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1932120" y="2174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ff0000"/>
                  </a:solidFill>
                  <a:latin typeface="Arial"/>
                </a:rPr>
                <a:t>4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 flipH="1">
              <a:off x="1658880" y="214200"/>
              <a:ext cx="1605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1819440" y="147600"/>
              <a:ext cx="0" cy="13176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 flipH="1">
              <a:off x="1824120" y="345960"/>
              <a:ext cx="27288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2161440" y="285840"/>
              <a:ext cx="14378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AJ428514.1_R.norvegicus_Denmark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 flipH="1">
              <a:off x="1824120" y="414360"/>
              <a:ext cx="540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1943280" y="351000"/>
              <a:ext cx="1707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62.1_R.norvegicus_Society_Island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 flipH="1">
              <a:off x="1940040" y="477720"/>
              <a:ext cx="540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2058840" y="415800"/>
              <a:ext cx="15307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AY172581.1_R. norvegicus_Lab_strain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 flipH="1">
              <a:off x="1939680" y="544680"/>
              <a:ext cx="522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2057400" y="482760"/>
              <a:ext cx="17319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61.1_R. norvegicus_Society_Island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 flipH="1">
              <a:off x="1939680" y="611280"/>
              <a:ext cx="507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2057040" y="547560"/>
              <a:ext cx="1540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NC 001665.2_R.norvegicus_Lab_strain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 flipH="1">
              <a:off x="1824120" y="542880"/>
              <a:ext cx="11592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1940040" y="477720"/>
              <a:ext cx="0" cy="13356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 flipH="1">
              <a:off x="1658520" y="444600"/>
              <a:ext cx="16524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1824120" y="345960"/>
              <a:ext cx="0" cy="19692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 flipH="1">
              <a:off x="30240" y="330120"/>
              <a:ext cx="162864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1658880" y="214200"/>
              <a:ext cx="0" cy="23040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 flipH="1">
              <a:off x="3311280" y="676440"/>
              <a:ext cx="11412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3494160" y="614520"/>
              <a:ext cx="1402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512.1_R.tanezumi_Indonesi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 flipH="1">
              <a:off x="3421080" y="743040"/>
              <a:ext cx="540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3537000" y="68112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ff0000"/>
                  </a:solidFill>
                  <a:latin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 flipH="1">
              <a:off x="3420720" y="808200"/>
              <a:ext cx="522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3534120" y="746280"/>
              <a:ext cx="1958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ff0000"/>
                  </a:solidFill>
                  <a:latin typeface="Arial"/>
                </a:rPr>
                <a:t>115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 flipH="1">
              <a:off x="3421080" y="874800"/>
              <a:ext cx="5544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3538080" y="814320"/>
              <a:ext cx="1958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ff0000"/>
                  </a:solidFill>
                  <a:latin typeface="Arial"/>
                </a:rPr>
                <a:t>119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 flipH="1">
              <a:off x="3421080" y="941400"/>
              <a:ext cx="540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3537360" y="879480"/>
              <a:ext cx="122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ff0000"/>
                  </a:solidFill>
                  <a:latin typeface="Arial"/>
                </a:rPr>
                <a:t>49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 flipH="1">
              <a:off x="3421080" y="1006560"/>
              <a:ext cx="540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3537360" y="944640"/>
              <a:ext cx="122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ff0000"/>
                  </a:solidFill>
                  <a:latin typeface="Arial"/>
                </a:rPr>
                <a:t>50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 flipH="1">
              <a:off x="3421080" y="1073160"/>
              <a:ext cx="5544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3537360" y="1011240"/>
              <a:ext cx="738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ff0000"/>
                  </a:solidFill>
                  <a:latin typeface="Arial"/>
                </a:rPr>
                <a:t>7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 flipH="1">
              <a:off x="3421080" y="1138320"/>
              <a:ext cx="540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3537360" y="1076400"/>
              <a:ext cx="738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ff0000"/>
                  </a:solidFill>
                  <a:latin typeface="Arial"/>
                </a:rPr>
                <a:t>8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 flipH="1">
              <a:off x="3421080" y="1204920"/>
              <a:ext cx="540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3543120" y="1143000"/>
              <a:ext cx="14958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12.1_R.rattus_diardi_Malaysi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 flipH="1">
              <a:off x="3420720" y="1271520"/>
              <a:ext cx="522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3539520" y="1209600"/>
              <a:ext cx="1402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90.1_R.tanezumi_Indonesi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 flipH="1">
              <a:off x="3421080" y="1335240"/>
              <a:ext cx="540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3542040" y="1274760"/>
              <a:ext cx="1402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97.1_R.tanezumi_Indonesi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 flipH="1">
              <a:off x="3421080" y="1403280"/>
              <a:ext cx="540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3540960" y="1341360"/>
              <a:ext cx="973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98.1_R.tanezum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 flipH="1">
              <a:off x="3420720" y="1469880"/>
              <a:ext cx="522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3537720" y="1407960"/>
              <a:ext cx="973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99.1_R.tanezum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 flipH="1">
              <a:off x="3532320" y="1533600"/>
              <a:ext cx="540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3652920" y="1473120"/>
              <a:ext cx="15156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10.1_R.rattus_diardii_Malaysi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 flipH="1">
              <a:off x="3532320" y="1601640"/>
              <a:ext cx="5688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3655440" y="1538280"/>
              <a:ext cx="15156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11.1_R.rattus_diardii_Malaysi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 flipH="1">
              <a:off x="3532320" y="1666800"/>
              <a:ext cx="6192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3658680" y="1604880"/>
              <a:ext cx="1402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511.1_R.tanezumi_Indonesi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 flipH="1">
              <a:off x="3420720" y="1600200"/>
              <a:ext cx="11124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3532320" y="1533600"/>
              <a:ext cx="0" cy="13320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 flipH="1">
              <a:off x="3530520" y="1731960"/>
              <a:ext cx="540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3651120" y="1671480"/>
              <a:ext cx="1462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44.1_R.kandianus_Sri_Lank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 flipH="1">
              <a:off x="3530160" y="1800360"/>
              <a:ext cx="5868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3654360" y="1736640"/>
              <a:ext cx="1462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45.1_R.kandianus_Sri_Lank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 flipH="1">
              <a:off x="3530160" y="1863720"/>
              <a:ext cx="5868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3654360" y="1803240"/>
              <a:ext cx="1462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46.1_R.kandianus_Sri_Lank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 flipH="1">
              <a:off x="3421080" y="1798560"/>
              <a:ext cx="10944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3530520" y="1731960"/>
              <a:ext cx="0" cy="13176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 flipH="1">
              <a:off x="3311640" y="1270080"/>
              <a:ext cx="10944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3421080" y="743040"/>
              <a:ext cx="0" cy="105552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 flipH="1">
              <a:off x="3589200" y="1930320"/>
              <a:ext cx="540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3702240" y="1870200"/>
              <a:ext cx="146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ff0000"/>
                  </a:solidFill>
                  <a:latin typeface="Arial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 flipH="1">
              <a:off x="3589200" y="1996920"/>
              <a:ext cx="540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3702240" y="1933560"/>
              <a:ext cx="146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ff0000"/>
                  </a:solidFill>
                  <a:latin typeface="Arial"/>
                </a:rPr>
                <a:t>13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 flipH="1">
              <a:off x="3589200" y="2062080"/>
              <a:ext cx="525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3700800" y="2001960"/>
              <a:ext cx="146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ff0000"/>
                  </a:solidFill>
                  <a:latin typeface="Arial"/>
                </a:rPr>
                <a:t>13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 flipH="1">
              <a:off x="3589200" y="2128680"/>
              <a:ext cx="525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3706200" y="2068560"/>
              <a:ext cx="1402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96.1_R.tanezumi_Indonesi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 flipH="1">
              <a:off x="3589200" y="2195640"/>
              <a:ext cx="540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3707640" y="2131920"/>
              <a:ext cx="1402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500.1_R.tanezumi_Indonesi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 flipH="1">
              <a:off x="3589200" y="2260440"/>
              <a:ext cx="525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3706200" y="2200320"/>
              <a:ext cx="1402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501.1_R.tanezumi_Indonesi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 flipH="1">
              <a:off x="3589200" y="2327400"/>
              <a:ext cx="540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3707640" y="2265480"/>
              <a:ext cx="1402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506.1_R.tanezumi_Indonesi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 flipH="1">
              <a:off x="3311280" y="2128680"/>
              <a:ext cx="2775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3589200" y="1930320"/>
              <a:ext cx="0" cy="39708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 flipH="1">
              <a:off x="2665080" y="1403280"/>
              <a:ext cx="6462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3311640" y="676440"/>
              <a:ext cx="0" cy="145224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 flipH="1">
              <a:off x="3251160" y="2394000"/>
              <a:ext cx="1620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3473640" y="2330280"/>
              <a:ext cx="1958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ff0000"/>
                  </a:solidFill>
                  <a:latin typeface="Arial"/>
                </a:rPr>
                <a:t>119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 flipH="1">
              <a:off x="3251160" y="2459160"/>
              <a:ext cx="10944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3426840" y="2398680"/>
              <a:ext cx="1402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92.1_R.tanezumi_Indonesi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 flipH="1">
              <a:off x="3357720" y="2523960"/>
              <a:ext cx="5544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3473640" y="2462040"/>
              <a:ext cx="1958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ff0000"/>
                  </a:solidFill>
                  <a:latin typeface="Arial"/>
                </a:rPr>
                <a:t>113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 flipH="1">
              <a:off x="3357360" y="2590920"/>
              <a:ext cx="522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3471480" y="2529000"/>
              <a:ext cx="1958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ff0000"/>
                  </a:solidFill>
                  <a:latin typeface="Arial"/>
                </a:rPr>
                <a:t>114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 flipH="1">
              <a:off x="3251160" y="2558880"/>
              <a:ext cx="1065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3357720" y="2523960"/>
              <a:ext cx="0" cy="6696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 flipH="1">
              <a:off x="3357360" y="2657520"/>
              <a:ext cx="5868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>
              <a:off x="3484440" y="2597040"/>
              <a:ext cx="1466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513.1_R.tiomanicus_Indonesi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 flipH="1">
              <a:off x="3357720" y="2722680"/>
              <a:ext cx="6192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>
              <a:off x="3485520" y="2660760"/>
              <a:ext cx="1466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514.1_R.tiomanicus_Indonesi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"/>
            <p:cNvSpPr/>
            <p:nvPr/>
          </p:nvSpPr>
          <p:spPr>
            <a:xfrm flipH="1">
              <a:off x="3251160" y="2689200"/>
              <a:ext cx="1065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>
              <a:off x="3357720" y="2657520"/>
              <a:ext cx="0" cy="6516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"/>
            <p:cNvSpPr/>
            <p:nvPr/>
          </p:nvSpPr>
          <p:spPr>
            <a:xfrm flipH="1">
              <a:off x="2894040" y="2540160"/>
              <a:ext cx="35712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"/>
            <p:cNvSpPr/>
            <p:nvPr/>
          </p:nvSpPr>
          <p:spPr>
            <a:xfrm>
              <a:off x="3251160" y="2394000"/>
              <a:ext cx="0" cy="29520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"/>
            <p:cNvSpPr/>
            <p:nvPr/>
          </p:nvSpPr>
          <p:spPr>
            <a:xfrm flipH="1">
              <a:off x="4216320" y="2789280"/>
              <a:ext cx="525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"/>
            <p:cNvSpPr/>
            <p:nvPr/>
          </p:nvSpPr>
          <p:spPr>
            <a:xfrm>
              <a:off x="4333320" y="2727360"/>
              <a:ext cx="1402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502.1_R.tanezumi_Indonesi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 flipH="1">
              <a:off x="4215960" y="2855880"/>
              <a:ext cx="5724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"/>
            <p:cNvSpPr/>
            <p:nvPr/>
          </p:nvSpPr>
          <p:spPr>
            <a:xfrm>
              <a:off x="4340520" y="2793960"/>
              <a:ext cx="1402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504.1_R.tanezumi_Indonesi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"/>
            <p:cNvSpPr/>
            <p:nvPr/>
          </p:nvSpPr>
          <p:spPr>
            <a:xfrm flipH="1">
              <a:off x="4216320" y="2921040"/>
              <a:ext cx="540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"/>
            <p:cNvSpPr/>
            <p:nvPr/>
          </p:nvSpPr>
          <p:spPr>
            <a:xfrm>
              <a:off x="4334760" y="2859120"/>
              <a:ext cx="1402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505.1_R.tanezumi_Indonesi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"/>
            <p:cNvSpPr/>
            <p:nvPr/>
          </p:nvSpPr>
          <p:spPr>
            <a:xfrm flipH="1">
              <a:off x="4215960" y="2987640"/>
              <a:ext cx="558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"/>
            <p:cNvSpPr/>
            <p:nvPr/>
          </p:nvSpPr>
          <p:spPr>
            <a:xfrm>
              <a:off x="4336560" y="2925720"/>
              <a:ext cx="1402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507.1_R.tanezumi_Indonesi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"/>
            <p:cNvSpPr/>
            <p:nvPr/>
          </p:nvSpPr>
          <p:spPr>
            <a:xfrm flipH="1">
              <a:off x="4668480" y="3052800"/>
              <a:ext cx="5868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"/>
            <p:cNvSpPr/>
            <p:nvPr/>
          </p:nvSpPr>
          <p:spPr>
            <a:xfrm>
              <a:off x="4788360" y="2990880"/>
              <a:ext cx="1958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ff0000"/>
                  </a:solidFill>
                  <a:latin typeface="Arial"/>
                </a:rPr>
                <a:t>117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"/>
            <p:cNvSpPr/>
            <p:nvPr/>
          </p:nvSpPr>
          <p:spPr>
            <a:xfrm flipH="1">
              <a:off x="4668840" y="3117960"/>
              <a:ext cx="6048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"/>
            <p:cNvSpPr/>
            <p:nvPr/>
          </p:nvSpPr>
          <p:spPr>
            <a:xfrm>
              <a:off x="4795920" y="3057480"/>
              <a:ext cx="1402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91.1_R.tanezumi_Indonesi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"/>
            <p:cNvSpPr/>
            <p:nvPr/>
          </p:nvSpPr>
          <p:spPr>
            <a:xfrm flipH="1">
              <a:off x="4321080" y="3086280"/>
              <a:ext cx="3477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"/>
            <p:cNvSpPr/>
            <p:nvPr/>
          </p:nvSpPr>
          <p:spPr>
            <a:xfrm>
              <a:off x="4668840" y="3052800"/>
              <a:ext cx="0" cy="6516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"/>
            <p:cNvSpPr/>
            <p:nvPr/>
          </p:nvSpPr>
          <p:spPr>
            <a:xfrm flipH="1">
              <a:off x="4447800" y="3186000"/>
              <a:ext cx="4932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"/>
            <p:cNvSpPr/>
            <p:nvPr/>
          </p:nvSpPr>
          <p:spPr>
            <a:xfrm>
              <a:off x="4560480" y="3124080"/>
              <a:ext cx="1311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40.1_R.flavipectus_Chin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"/>
            <p:cNvSpPr/>
            <p:nvPr/>
          </p:nvSpPr>
          <p:spPr>
            <a:xfrm flipH="1">
              <a:off x="4447800" y="3251160"/>
              <a:ext cx="507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"/>
            <p:cNvSpPr/>
            <p:nvPr/>
          </p:nvSpPr>
          <p:spPr>
            <a:xfrm>
              <a:off x="4564080" y="3189240"/>
              <a:ext cx="12016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509.1_Tanezumi_Japan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"/>
            <p:cNvSpPr/>
            <p:nvPr/>
          </p:nvSpPr>
          <p:spPr>
            <a:xfrm flipH="1">
              <a:off x="4448160" y="3316320"/>
              <a:ext cx="525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"/>
            <p:cNvSpPr/>
            <p:nvPr/>
          </p:nvSpPr>
          <p:spPr>
            <a:xfrm>
              <a:off x="4568400" y="3255840"/>
              <a:ext cx="1261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510.1_R.tanezumi_Japan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"/>
            <p:cNvSpPr/>
            <p:nvPr/>
          </p:nvSpPr>
          <p:spPr>
            <a:xfrm flipH="1">
              <a:off x="4320720" y="3251160"/>
              <a:ext cx="12708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"/>
            <p:cNvSpPr/>
            <p:nvPr/>
          </p:nvSpPr>
          <p:spPr>
            <a:xfrm>
              <a:off x="4448160" y="3186000"/>
              <a:ext cx="0" cy="13032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"/>
            <p:cNvSpPr/>
            <p:nvPr/>
          </p:nvSpPr>
          <p:spPr>
            <a:xfrm flipH="1">
              <a:off x="4215960" y="3168720"/>
              <a:ext cx="1047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"/>
            <p:cNvSpPr/>
            <p:nvPr/>
          </p:nvSpPr>
          <p:spPr>
            <a:xfrm>
              <a:off x="4321080" y="3086280"/>
              <a:ext cx="0" cy="16488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"/>
            <p:cNvSpPr/>
            <p:nvPr/>
          </p:nvSpPr>
          <p:spPr>
            <a:xfrm flipH="1">
              <a:off x="4322520" y="3382920"/>
              <a:ext cx="522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"/>
            <p:cNvSpPr/>
            <p:nvPr/>
          </p:nvSpPr>
          <p:spPr>
            <a:xfrm>
              <a:off x="4441320" y="3319560"/>
              <a:ext cx="1402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93.1_R.tanezumi_Indonesi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"/>
            <p:cNvSpPr/>
            <p:nvPr/>
          </p:nvSpPr>
          <p:spPr>
            <a:xfrm flipH="1">
              <a:off x="4322880" y="3449520"/>
              <a:ext cx="1029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"/>
            <p:cNvSpPr/>
            <p:nvPr/>
          </p:nvSpPr>
          <p:spPr>
            <a:xfrm>
              <a:off x="4492080" y="3387600"/>
              <a:ext cx="1402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94.1_R.tanezumi_Indonesi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"/>
            <p:cNvSpPr/>
            <p:nvPr/>
          </p:nvSpPr>
          <p:spPr>
            <a:xfrm flipH="1">
              <a:off x="4322520" y="3514680"/>
              <a:ext cx="522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"/>
            <p:cNvSpPr/>
            <p:nvPr/>
          </p:nvSpPr>
          <p:spPr>
            <a:xfrm>
              <a:off x="4441320" y="3454560"/>
              <a:ext cx="1402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95.1_R.tanezumi_Indonesi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"/>
            <p:cNvSpPr/>
            <p:nvPr/>
          </p:nvSpPr>
          <p:spPr>
            <a:xfrm flipH="1">
              <a:off x="4322520" y="3581280"/>
              <a:ext cx="522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"/>
            <p:cNvSpPr/>
            <p:nvPr/>
          </p:nvSpPr>
          <p:spPr>
            <a:xfrm>
              <a:off x="4441320" y="3517920"/>
              <a:ext cx="1402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503.1_R.tanezumi_Indonesi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"/>
            <p:cNvSpPr/>
            <p:nvPr/>
          </p:nvSpPr>
          <p:spPr>
            <a:xfrm flipH="1">
              <a:off x="4216320" y="3479760"/>
              <a:ext cx="1065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"/>
            <p:cNvSpPr/>
            <p:nvPr/>
          </p:nvSpPr>
          <p:spPr>
            <a:xfrm>
              <a:off x="4322880" y="3382920"/>
              <a:ext cx="0" cy="19836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"/>
            <p:cNvSpPr/>
            <p:nvPr/>
          </p:nvSpPr>
          <p:spPr>
            <a:xfrm flipH="1">
              <a:off x="3460320" y="3135240"/>
              <a:ext cx="75564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"/>
            <p:cNvSpPr/>
            <p:nvPr/>
          </p:nvSpPr>
          <p:spPr>
            <a:xfrm>
              <a:off x="4216320" y="2789280"/>
              <a:ext cx="0" cy="69048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"/>
            <p:cNvSpPr/>
            <p:nvPr/>
          </p:nvSpPr>
          <p:spPr>
            <a:xfrm flipH="1">
              <a:off x="4068360" y="3646440"/>
              <a:ext cx="5868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"/>
            <p:cNvSpPr/>
            <p:nvPr/>
          </p:nvSpPr>
          <p:spPr>
            <a:xfrm>
              <a:off x="4192200" y="3586320"/>
              <a:ext cx="1501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69.1_R.rattus_Society_Island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"/>
            <p:cNvSpPr/>
            <p:nvPr/>
          </p:nvSpPr>
          <p:spPr>
            <a:xfrm flipH="1">
              <a:off x="4068720" y="3713040"/>
              <a:ext cx="540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"/>
            <p:cNvSpPr/>
            <p:nvPr/>
          </p:nvSpPr>
          <p:spPr>
            <a:xfrm>
              <a:off x="4186800" y="3652920"/>
              <a:ext cx="14270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70.1_R.rattus_New_Zealand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"/>
            <p:cNvSpPr/>
            <p:nvPr/>
          </p:nvSpPr>
          <p:spPr>
            <a:xfrm flipH="1">
              <a:off x="4068720" y="3780000"/>
              <a:ext cx="525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"/>
            <p:cNvSpPr/>
            <p:nvPr/>
          </p:nvSpPr>
          <p:spPr>
            <a:xfrm>
              <a:off x="4187520" y="3716280"/>
              <a:ext cx="16970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72.1_R.rattus_Papua_New_Guine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"/>
            <p:cNvSpPr/>
            <p:nvPr/>
          </p:nvSpPr>
          <p:spPr>
            <a:xfrm flipH="1">
              <a:off x="4068720" y="3844800"/>
              <a:ext cx="525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"/>
            <p:cNvSpPr/>
            <p:nvPr/>
          </p:nvSpPr>
          <p:spPr>
            <a:xfrm>
              <a:off x="4187520" y="3784680"/>
              <a:ext cx="1501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74.1_R.rattus_Society_Island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"/>
            <p:cNvSpPr/>
            <p:nvPr/>
          </p:nvSpPr>
          <p:spPr>
            <a:xfrm flipH="1">
              <a:off x="4068720" y="3909960"/>
              <a:ext cx="540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"/>
            <p:cNvSpPr/>
            <p:nvPr/>
          </p:nvSpPr>
          <p:spPr>
            <a:xfrm>
              <a:off x="4186800" y="3848040"/>
              <a:ext cx="1163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75.1_R.rattus_Samo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"/>
            <p:cNvSpPr/>
            <p:nvPr/>
          </p:nvSpPr>
          <p:spPr>
            <a:xfrm flipH="1">
              <a:off x="3460320" y="3780000"/>
              <a:ext cx="60804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"/>
            <p:cNvSpPr/>
            <p:nvPr/>
          </p:nvSpPr>
          <p:spPr>
            <a:xfrm>
              <a:off x="4068720" y="3646440"/>
              <a:ext cx="0" cy="26352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"/>
            <p:cNvSpPr/>
            <p:nvPr/>
          </p:nvSpPr>
          <p:spPr>
            <a:xfrm flipH="1">
              <a:off x="2894040" y="3457440"/>
              <a:ext cx="56664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"/>
            <p:cNvSpPr/>
            <p:nvPr/>
          </p:nvSpPr>
          <p:spPr>
            <a:xfrm>
              <a:off x="3460680" y="3135240"/>
              <a:ext cx="0" cy="64476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"/>
            <p:cNvSpPr/>
            <p:nvPr/>
          </p:nvSpPr>
          <p:spPr>
            <a:xfrm flipH="1">
              <a:off x="2665080" y="2997360"/>
              <a:ext cx="2286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"/>
            <p:cNvSpPr/>
            <p:nvPr/>
          </p:nvSpPr>
          <p:spPr>
            <a:xfrm>
              <a:off x="2894040" y="2540160"/>
              <a:ext cx="0" cy="91728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"/>
            <p:cNvSpPr/>
            <p:nvPr/>
          </p:nvSpPr>
          <p:spPr>
            <a:xfrm flipH="1">
              <a:off x="2279520" y="2201760"/>
              <a:ext cx="38592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"/>
            <p:cNvSpPr/>
            <p:nvPr/>
          </p:nvSpPr>
          <p:spPr>
            <a:xfrm>
              <a:off x="2665440" y="1403280"/>
              <a:ext cx="0" cy="159408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"/>
            <p:cNvSpPr/>
            <p:nvPr/>
          </p:nvSpPr>
          <p:spPr>
            <a:xfrm flipH="1">
              <a:off x="3260880" y="3978360"/>
              <a:ext cx="12528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"/>
            <p:cNvSpPr/>
            <p:nvPr/>
          </p:nvSpPr>
          <p:spPr>
            <a:xfrm>
              <a:off x="3455280" y="3914640"/>
              <a:ext cx="14317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41.1_R.hoffmanni_Indonesi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"/>
            <p:cNvSpPr/>
            <p:nvPr/>
          </p:nvSpPr>
          <p:spPr>
            <a:xfrm flipH="1">
              <a:off x="3365640" y="4043520"/>
              <a:ext cx="540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"/>
            <p:cNvSpPr/>
            <p:nvPr/>
          </p:nvSpPr>
          <p:spPr>
            <a:xfrm>
              <a:off x="3486240" y="3983040"/>
              <a:ext cx="14317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42.1_R.hoffmanni_Indonesi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"/>
            <p:cNvSpPr/>
            <p:nvPr/>
          </p:nvSpPr>
          <p:spPr>
            <a:xfrm flipH="1">
              <a:off x="3365640" y="4108320"/>
              <a:ext cx="5688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"/>
            <p:cNvSpPr/>
            <p:nvPr/>
          </p:nvSpPr>
          <p:spPr>
            <a:xfrm>
              <a:off x="3489480" y="4046400"/>
              <a:ext cx="14317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43.1_R.hoffmanni_Indonesi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"/>
            <p:cNvSpPr/>
            <p:nvPr/>
          </p:nvSpPr>
          <p:spPr>
            <a:xfrm flipH="1">
              <a:off x="3260520" y="4075200"/>
              <a:ext cx="1047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"/>
            <p:cNvSpPr/>
            <p:nvPr/>
          </p:nvSpPr>
          <p:spPr>
            <a:xfrm>
              <a:off x="3365640" y="4043520"/>
              <a:ext cx="0" cy="6480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"/>
            <p:cNvSpPr/>
            <p:nvPr/>
          </p:nvSpPr>
          <p:spPr>
            <a:xfrm flipH="1">
              <a:off x="2279520" y="4027320"/>
              <a:ext cx="9813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"/>
            <p:cNvSpPr/>
            <p:nvPr/>
          </p:nvSpPr>
          <p:spPr>
            <a:xfrm>
              <a:off x="3260880" y="3978360"/>
              <a:ext cx="0" cy="9684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"/>
            <p:cNvSpPr/>
            <p:nvPr/>
          </p:nvSpPr>
          <p:spPr>
            <a:xfrm flipH="1">
              <a:off x="1690560" y="3112920"/>
              <a:ext cx="5889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"/>
            <p:cNvSpPr/>
            <p:nvPr/>
          </p:nvSpPr>
          <p:spPr>
            <a:xfrm>
              <a:off x="2279520" y="2201760"/>
              <a:ext cx="0" cy="182556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"/>
            <p:cNvSpPr/>
            <p:nvPr/>
          </p:nvSpPr>
          <p:spPr>
            <a:xfrm flipH="1">
              <a:off x="3472920" y="4176720"/>
              <a:ext cx="5724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"/>
            <p:cNvSpPr/>
            <p:nvPr/>
          </p:nvSpPr>
          <p:spPr>
            <a:xfrm>
              <a:off x="3595680" y="4113360"/>
              <a:ext cx="1501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14.1_R.exulans_Cook_Island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"/>
            <p:cNvSpPr/>
            <p:nvPr/>
          </p:nvSpPr>
          <p:spPr>
            <a:xfrm flipH="1">
              <a:off x="3472920" y="4241880"/>
              <a:ext cx="4932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"/>
            <p:cNvSpPr/>
            <p:nvPr/>
          </p:nvSpPr>
          <p:spPr>
            <a:xfrm>
              <a:off x="3587760" y="4181400"/>
              <a:ext cx="1501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15.1_R.exulans_Cook_Island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"/>
            <p:cNvSpPr/>
            <p:nvPr/>
          </p:nvSpPr>
          <p:spPr>
            <a:xfrm flipH="1">
              <a:off x="3473280" y="4307040"/>
              <a:ext cx="525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"/>
            <p:cNvSpPr/>
            <p:nvPr/>
          </p:nvSpPr>
          <p:spPr>
            <a:xfrm>
              <a:off x="3592080" y="4245120"/>
              <a:ext cx="1497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16.1_R.exulans_Cook_island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"/>
            <p:cNvSpPr/>
            <p:nvPr/>
          </p:nvSpPr>
          <p:spPr>
            <a:xfrm flipH="1">
              <a:off x="3473280" y="4373640"/>
              <a:ext cx="525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"/>
            <p:cNvSpPr/>
            <p:nvPr/>
          </p:nvSpPr>
          <p:spPr>
            <a:xfrm>
              <a:off x="3590640" y="4311720"/>
              <a:ext cx="1081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17.1_R.exulans_Fij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"/>
            <p:cNvSpPr/>
            <p:nvPr/>
          </p:nvSpPr>
          <p:spPr>
            <a:xfrm flipH="1">
              <a:off x="3472920" y="4438800"/>
              <a:ext cx="9684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"/>
            <p:cNvSpPr/>
            <p:nvPr/>
          </p:nvSpPr>
          <p:spPr>
            <a:xfrm>
              <a:off x="3632760" y="4378320"/>
              <a:ext cx="12337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18.1_R.exulans_Hawai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"/>
            <p:cNvSpPr/>
            <p:nvPr/>
          </p:nvSpPr>
          <p:spPr>
            <a:xfrm flipH="1">
              <a:off x="3473280" y="4505400"/>
              <a:ext cx="525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"/>
            <p:cNvSpPr/>
            <p:nvPr/>
          </p:nvSpPr>
          <p:spPr>
            <a:xfrm>
              <a:off x="3590640" y="4443480"/>
              <a:ext cx="12337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19.1_R.exulans_Hawai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"/>
            <p:cNvSpPr/>
            <p:nvPr/>
          </p:nvSpPr>
          <p:spPr>
            <a:xfrm flipH="1">
              <a:off x="3472920" y="4572000"/>
              <a:ext cx="1098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"/>
            <p:cNvSpPr/>
            <p:nvPr/>
          </p:nvSpPr>
          <p:spPr>
            <a:xfrm>
              <a:off x="3647880" y="4510080"/>
              <a:ext cx="15858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20.1_R.exulans_Society_Island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"/>
            <p:cNvSpPr/>
            <p:nvPr/>
          </p:nvSpPr>
          <p:spPr>
            <a:xfrm flipH="1">
              <a:off x="3473280" y="4637160"/>
              <a:ext cx="525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"/>
            <p:cNvSpPr/>
            <p:nvPr/>
          </p:nvSpPr>
          <p:spPr>
            <a:xfrm>
              <a:off x="3595320" y="4575240"/>
              <a:ext cx="1730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22.1_R.exulans_Marquesas_Island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"/>
            <p:cNvSpPr/>
            <p:nvPr/>
          </p:nvSpPr>
          <p:spPr>
            <a:xfrm flipH="1">
              <a:off x="3473280" y="4703760"/>
              <a:ext cx="10008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"/>
            <p:cNvSpPr/>
            <p:nvPr/>
          </p:nvSpPr>
          <p:spPr>
            <a:xfrm>
              <a:off x="3641760" y="4641840"/>
              <a:ext cx="1730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23.1_R.exulans_Marquesas_Island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"/>
            <p:cNvSpPr/>
            <p:nvPr/>
          </p:nvSpPr>
          <p:spPr>
            <a:xfrm flipH="1">
              <a:off x="3472920" y="4768920"/>
              <a:ext cx="4932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"/>
            <p:cNvSpPr/>
            <p:nvPr/>
          </p:nvSpPr>
          <p:spPr>
            <a:xfrm>
              <a:off x="3587040" y="4707000"/>
              <a:ext cx="1510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24.1_R.exulans_New_Zealand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"/>
            <p:cNvSpPr/>
            <p:nvPr/>
          </p:nvSpPr>
          <p:spPr>
            <a:xfrm flipH="1">
              <a:off x="3473280" y="4835520"/>
              <a:ext cx="525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"/>
            <p:cNvSpPr/>
            <p:nvPr/>
          </p:nvSpPr>
          <p:spPr>
            <a:xfrm>
              <a:off x="3592440" y="4773600"/>
              <a:ext cx="1510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25.1_R.exulans_New_Zealand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"/>
            <p:cNvSpPr/>
            <p:nvPr/>
          </p:nvSpPr>
          <p:spPr>
            <a:xfrm flipH="1">
              <a:off x="3473280" y="4900680"/>
              <a:ext cx="1065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"/>
            <p:cNvSpPr/>
            <p:nvPr/>
          </p:nvSpPr>
          <p:spPr>
            <a:xfrm>
              <a:off x="3645000" y="4840200"/>
              <a:ext cx="1510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26.1_R.exulans_New_Zealand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"/>
            <p:cNvSpPr/>
            <p:nvPr/>
          </p:nvSpPr>
          <p:spPr>
            <a:xfrm flipH="1">
              <a:off x="3473280" y="4967280"/>
              <a:ext cx="525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"/>
            <p:cNvSpPr/>
            <p:nvPr/>
          </p:nvSpPr>
          <p:spPr>
            <a:xfrm>
              <a:off x="3593160" y="4905360"/>
              <a:ext cx="15858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29.1_R.exulans_Society_Island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"/>
            <p:cNvSpPr/>
            <p:nvPr/>
          </p:nvSpPr>
          <p:spPr>
            <a:xfrm flipH="1">
              <a:off x="3472920" y="5033880"/>
              <a:ext cx="558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"/>
            <p:cNvSpPr/>
            <p:nvPr/>
          </p:nvSpPr>
          <p:spPr>
            <a:xfrm>
              <a:off x="3593160" y="4971960"/>
              <a:ext cx="12474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30.1_R.exulans_Samo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"/>
            <p:cNvSpPr/>
            <p:nvPr/>
          </p:nvSpPr>
          <p:spPr>
            <a:xfrm flipH="1">
              <a:off x="3472920" y="5100480"/>
              <a:ext cx="1098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"/>
            <p:cNvSpPr/>
            <p:nvPr/>
          </p:nvSpPr>
          <p:spPr>
            <a:xfrm>
              <a:off x="3647160" y="5038560"/>
              <a:ext cx="12474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31.1_R.exulans_Samo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"/>
            <p:cNvSpPr/>
            <p:nvPr/>
          </p:nvSpPr>
          <p:spPr>
            <a:xfrm flipH="1">
              <a:off x="3638520" y="5165640"/>
              <a:ext cx="525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"/>
            <p:cNvSpPr/>
            <p:nvPr/>
          </p:nvSpPr>
          <p:spPr>
            <a:xfrm>
              <a:off x="3749400" y="5102280"/>
              <a:ext cx="1958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ff0000"/>
                  </a:solidFill>
                  <a:latin typeface="Arial"/>
                </a:rPr>
                <a:t>113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"/>
            <p:cNvSpPr/>
            <p:nvPr/>
          </p:nvSpPr>
          <p:spPr>
            <a:xfrm flipH="1">
              <a:off x="3638520" y="5232240"/>
              <a:ext cx="525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"/>
            <p:cNvSpPr/>
            <p:nvPr/>
          </p:nvSpPr>
          <p:spPr>
            <a:xfrm>
              <a:off x="3750120" y="5170320"/>
              <a:ext cx="146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ff0000"/>
                  </a:solidFill>
                  <a:latin typeface="Arial"/>
                </a:rPr>
                <a:t>52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"/>
            <p:cNvSpPr/>
            <p:nvPr/>
          </p:nvSpPr>
          <p:spPr>
            <a:xfrm flipH="1">
              <a:off x="3472920" y="5199120"/>
              <a:ext cx="16524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"/>
            <p:cNvSpPr/>
            <p:nvPr/>
          </p:nvSpPr>
          <p:spPr>
            <a:xfrm>
              <a:off x="3638520" y="5165640"/>
              <a:ext cx="0" cy="6660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"/>
            <p:cNvSpPr/>
            <p:nvPr/>
          </p:nvSpPr>
          <p:spPr>
            <a:xfrm flipH="1">
              <a:off x="3635280" y="5297400"/>
              <a:ext cx="1080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"/>
            <p:cNvSpPr/>
            <p:nvPr/>
          </p:nvSpPr>
          <p:spPr>
            <a:xfrm>
              <a:off x="3802320" y="5235480"/>
              <a:ext cx="146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ff0000"/>
                  </a:solidFill>
                  <a:latin typeface="Arial"/>
                </a:rPr>
                <a:t>35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"/>
            <p:cNvSpPr/>
            <p:nvPr/>
          </p:nvSpPr>
          <p:spPr>
            <a:xfrm flipH="1">
              <a:off x="3634920" y="5364000"/>
              <a:ext cx="1098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"/>
            <p:cNvSpPr/>
            <p:nvPr/>
          </p:nvSpPr>
          <p:spPr>
            <a:xfrm>
              <a:off x="3808080" y="5300640"/>
              <a:ext cx="1349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21.1_R.exulans_Indonesi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"/>
            <p:cNvSpPr/>
            <p:nvPr/>
          </p:nvSpPr>
          <p:spPr>
            <a:xfrm flipH="1">
              <a:off x="3634920" y="5429160"/>
              <a:ext cx="5724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"/>
            <p:cNvSpPr/>
            <p:nvPr/>
          </p:nvSpPr>
          <p:spPr>
            <a:xfrm>
              <a:off x="3755520" y="5369040"/>
              <a:ext cx="14774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27.1_R.exulans_New_Guine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"/>
            <p:cNvSpPr/>
            <p:nvPr/>
          </p:nvSpPr>
          <p:spPr>
            <a:xfrm flipH="1">
              <a:off x="3635280" y="5495760"/>
              <a:ext cx="540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"/>
            <p:cNvSpPr/>
            <p:nvPr/>
          </p:nvSpPr>
          <p:spPr>
            <a:xfrm>
              <a:off x="3752280" y="5432400"/>
              <a:ext cx="14774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28.1_R.exulans_New_Guine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"/>
            <p:cNvSpPr/>
            <p:nvPr/>
          </p:nvSpPr>
          <p:spPr>
            <a:xfrm flipH="1">
              <a:off x="3634920" y="5562720"/>
              <a:ext cx="507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"/>
            <p:cNvSpPr/>
            <p:nvPr/>
          </p:nvSpPr>
          <p:spPr>
            <a:xfrm>
              <a:off x="3750840" y="5499000"/>
              <a:ext cx="1379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84.1_R.steini_New_Guine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"/>
            <p:cNvSpPr/>
            <p:nvPr/>
          </p:nvSpPr>
          <p:spPr>
            <a:xfrm flipH="1">
              <a:off x="3635280" y="5627520"/>
              <a:ext cx="540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"/>
            <p:cNvSpPr/>
            <p:nvPr/>
          </p:nvSpPr>
          <p:spPr>
            <a:xfrm>
              <a:off x="3753720" y="5567400"/>
              <a:ext cx="162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523.1_R.verecundus_New_Guine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"/>
            <p:cNvSpPr/>
            <p:nvPr/>
          </p:nvSpPr>
          <p:spPr>
            <a:xfrm flipH="1">
              <a:off x="3743280" y="5694480"/>
              <a:ext cx="525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"/>
            <p:cNvSpPr/>
            <p:nvPr/>
          </p:nvSpPr>
          <p:spPr>
            <a:xfrm>
              <a:off x="3860640" y="5630760"/>
              <a:ext cx="13053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32.1_R.exulans_Thailand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"/>
            <p:cNvSpPr/>
            <p:nvPr/>
          </p:nvSpPr>
          <p:spPr>
            <a:xfrm flipH="1">
              <a:off x="3743280" y="5761080"/>
              <a:ext cx="525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"/>
            <p:cNvSpPr/>
            <p:nvPr/>
          </p:nvSpPr>
          <p:spPr>
            <a:xfrm>
              <a:off x="3860640" y="5697360"/>
              <a:ext cx="13053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33.1_R.exulans_Thailand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"/>
            <p:cNvSpPr/>
            <p:nvPr/>
          </p:nvSpPr>
          <p:spPr>
            <a:xfrm flipH="1">
              <a:off x="3742920" y="5824440"/>
              <a:ext cx="507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"/>
            <p:cNvSpPr/>
            <p:nvPr/>
          </p:nvSpPr>
          <p:spPr>
            <a:xfrm>
              <a:off x="3856320" y="5764320"/>
              <a:ext cx="13053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34.1_R.exulans_Thailand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"/>
            <p:cNvSpPr/>
            <p:nvPr/>
          </p:nvSpPr>
          <p:spPr>
            <a:xfrm flipH="1">
              <a:off x="3635280" y="5759280"/>
              <a:ext cx="1080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"/>
            <p:cNvSpPr/>
            <p:nvPr/>
          </p:nvSpPr>
          <p:spPr>
            <a:xfrm>
              <a:off x="3743280" y="5694480"/>
              <a:ext cx="0" cy="12996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"/>
            <p:cNvSpPr/>
            <p:nvPr/>
          </p:nvSpPr>
          <p:spPr>
            <a:xfrm flipH="1">
              <a:off x="3473280" y="5527800"/>
              <a:ext cx="1620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"/>
            <p:cNvSpPr/>
            <p:nvPr/>
          </p:nvSpPr>
          <p:spPr>
            <a:xfrm>
              <a:off x="3635280" y="5297400"/>
              <a:ext cx="0" cy="46188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"/>
            <p:cNvSpPr/>
            <p:nvPr/>
          </p:nvSpPr>
          <p:spPr>
            <a:xfrm flipH="1">
              <a:off x="1690560" y="4851360"/>
              <a:ext cx="178272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"/>
            <p:cNvSpPr/>
            <p:nvPr/>
          </p:nvSpPr>
          <p:spPr>
            <a:xfrm>
              <a:off x="3473280" y="4176720"/>
              <a:ext cx="0" cy="135108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"/>
            <p:cNvSpPr/>
            <p:nvPr/>
          </p:nvSpPr>
          <p:spPr>
            <a:xfrm flipH="1">
              <a:off x="1044720" y="3983040"/>
              <a:ext cx="64584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"/>
            <p:cNvSpPr/>
            <p:nvPr/>
          </p:nvSpPr>
          <p:spPr>
            <a:xfrm>
              <a:off x="1690560" y="3112920"/>
              <a:ext cx="0" cy="173844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"/>
            <p:cNvSpPr/>
            <p:nvPr/>
          </p:nvSpPr>
          <p:spPr>
            <a:xfrm flipH="1">
              <a:off x="3612960" y="5892840"/>
              <a:ext cx="68724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"/>
            <p:cNvSpPr/>
            <p:nvPr/>
          </p:nvSpPr>
          <p:spPr>
            <a:xfrm>
              <a:off x="4366800" y="5829480"/>
              <a:ext cx="1331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35.1_R.fuscipes_Australi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"/>
            <p:cNvSpPr/>
            <p:nvPr/>
          </p:nvSpPr>
          <p:spPr>
            <a:xfrm flipH="1">
              <a:off x="4357440" y="5959440"/>
              <a:ext cx="5868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"/>
            <p:cNvSpPr/>
            <p:nvPr/>
          </p:nvSpPr>
          <p:spPr>
            <a:xfrm>
              <a:off x="4479480" y="5896080"/>
              <a:ext cx="1331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36.1_R.fuscipes_Australi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"/>
            <p:cNvSpPr/>
            <p:nvPr/>
          </p:nvSpPr>
          <p:spPr>
            <a:xfrm flipH="1">
              <a:off x="4357440" y="6022800"/>
              <a:ext cx="4428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"/>
            <p:cNvSpPr/>
            <p:nvPr/>
          </p:nvSpPr>
          <p:spPr>
            <a:xfrm>
              <a:off x="4466160" y="5962680"/>
              <a:ext cx="1302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37.1_R.fiscipes_Australi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"/>
            <p:cNvSpPr/>
            <p:nvPr/>
          </p:nvSpPr>
          <p:spPr>
            <a:xfrm flipH="1">
              <a:off x="3613320" y="5989680"/>
              <a:ext cx="74448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"/>
            <p:cNvSpPr/>
            <p:nvPr/>
          </p:nvSpPr>
          <p:spPr>
            <a:xfrm>
              <a:off x="4357800" y="5959440"/>
              <a:ext cx="0" cy="6336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560" bIns="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"/>
            <p:cNvSpPr/>
            <p:nvPr/>
          </p:nvSpPr>
          <p:spPr>
            <a:xfrm flipH="1">
              <a:off x="4467240" y="6091200"/>
              <a:ext cx="4413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"/>
            <p:cNvSpPr/>
            <p:nvPr/>
          </p:nvSpPr>
          <p:spPr>
            <a:xfrm>
              <a:off x="4976280" y="6027840"/>
              <a:ext cx="1331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38.1_R.fuscipes_Australi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"/>
            <p:cNvSpPr/>
            <p:nvPr/>
          </p:nvSpPr>
          <p:spPr>
            <a:xfrm flipH="1">
              <a:off x="4467240" y="6154560"/>
              <a:ext cx="3873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"/>
            <p:cNvSpPr/>
            <p:nvPr/>
          </p:nvSpPr>
          <p:spPr>
            <a:xfrm>
              <a:off x="4916880" y="6093000"/>
              <a:ext cx="1302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39.1_R.fiscipes_Australi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"/>
            <p:cNvSpPr/>
            <p:nvPr/>
          </p:nvSpPr>
          <p:spPr>
            <a:xfrm flipH="1">
              <a:off x="3613320" y="6122880"/>
              <a:ext cx="85392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"/>
            <p:cNvSpPr/>
            <p:nvPr/>
          </p:nvSpPr>
          <p:spPr>
            <a:xfrm>
              <a:off x="4467240" y="6091200"/>
              <a:ext cx="0" cy="6336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560" bIns="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"/>
            <p:cNvSpPr/>
            <p:nvPr/>
          </p:nvSpPr>
          <p:spPr>
            <a:xfrm flipH="1">
              <a:off x="2577960" y="6006960"/>
              <a:ext cx="10353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"/>
            <p:cNvSpPr/>
            <p:nvPr/>
          </p:nvSpPr>
          <p:spPr>
            <a:xfrm>
              <a:off x="3613320" y="5892840"/>
              <a:ext cx="0" cy="23004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"/>
            <p:cNvSpPr/>
            <p:nvPr/>
          </p:nvSpPr>
          <p:spPr>
            <a:xfrm flipH="1">
              <a:off x="4161960" y="6221520"/>
              <a:ext cx="16668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"/>
            <p:cNvSpPr/>
            <p:nvPr/>
          </p:nvSpPr>
          <p:spPr>
            <a:xfrm>
              <a:off x="4393440" y="6159600"/>
              <a:ext cx="1360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47.1_R.leucopus_Australi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"/>
            <p:cNvSpPr/>
            <p:nvPr/>
          </p:nvSpPr>
          <p:spPr>
            <a:xfrm flipH="1">
              <a:off x="4162320" y="6289560"/>
              <a:ext cx="4464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"/>
            <p:cNvSpPr/>
            <p:nvPr/>
          </p:nvSpPr>
          <p:spPr>
            <a:xfrm>
              <a:off x="4271400" y="6226200"/>
              <a:ext cx="1360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48.1_R.leucopus_Australi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"/>
            <p:cNvSpPr/>
            <p:nvPr/>
          </p:nvSpPr>
          <p:spPr>
            <a:xfrm flipH="1">
              <a:off x="3967200" y="6254640"/>
              <a:ext cx="19512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"/>
            <p:cNvSpPr/>
            <p:nvPr/>
          </p:nvSpPr>
          <p:spPr>
            <a:xfrm>
              <a:off x="4162320" y="6221520"/>
              <a:ext cx="0" cy="6804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"/>
            <p:cNvSpPr/>
            <p:nvPr/>
          </p:nvSpPr>
          <p:spPr>
            <a:xfrm flipH="1">
              <a:off x="4259160" y="6353280"/>
              <a:ext cx="540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"/>
            <p:cNvSpPr/>
            <p:nvPr/>
          </p:nvSpPr>
          <p:spPr>
            <a:xfrm>
              <a:off x="4379040" y="6291360"/>
              <a:ext cx="1360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51.1_R.leucopus_Australi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"/>
            <p:cNvSpPr/>
            <p:nvPr/>
          </p:nvSpPr>
          <p:spPr>
            <a:xfrm flipH="1">
              <a:off x="4259160" y="6419880"/>
              <a:ext cx="10008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"/>
            <p:cNvSpPr/>
            <p:nvPr/>
          </p:nvSpPr>
          <p:spPr>
            <a:xfrm>
              <a:off x="4423680" y="6357960"/>
              <a:ext cx="1360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52.1_R.leucopus_Australi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"/>
            <p:cNvSpPr/>
            <p:nvPr/>
          </p:nvSpPr>
          <p:spPr>
            <a:xfrm flipH="1">
              <a:off x="3966840" y="6386400"/>
              <a:ext cx="2919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"/>
            <p:cNvSpPr/>
            <p:nvPr/>
          </p:nvSpPr>
          <p:spPr>
            <a:xfrm>
              <a:off x="4259160" y="6353280"/>
              <a:ext cx="0" cy="6660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"/>
            <p:cNvSpPr/>
            <p:nvPr/>
          </p:nvSpPr>
          <p:spPr>
            <a:xfrm flipH="1">
              <a:off x="3484080" y="6319800"/>
              <a:ext cx="4827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"/>
            <p:cNvSpPr/>
            <p:nvPr/>
          </p:nvSpPr>
          <p:spPr>
            <a:xfrm>
              <a:off x="3967200" y="6254640"/>
              <a:ext cx="0" cy="13176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"/>
            <p:cNvSpPr/>
            <p:nvPr/>
          </p:nvSpPr>
          <p:spPr>
            <a:xfrm flipH="1">
              <a:off x="3875040" y="6488280"/>
              <a:ext cx="2541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"/>
            <p:cNvSpPr/>
            <p:nvPr/>
          </p:nvSpPr>
          <p:spPr>
            <a:xfrm>
              <a:off x="4192920" y="6424560"/>
              <a:ext cx="1829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49.1_R.leucopus_Papua_New_Guine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"/>
            <p:cNvSpPr/>
            <p:nvPr/>
          </p:nvSpPr>
          <p:spPr>
            <a:xfrm flipH="1">
              <a:off x="3874680" y="6551640"/>
              <a:ext cx="15732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"/>
            <p:cNvSpPr/>
            <p:nvPr/>
          </p:nvSpPr>
          <p:spPr>
            <a:xfrm>
              <a:off x="4096080" y="6491160"/>
              <a:ext cx="1829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50.1_R.leucopus_Papua_New_Guine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"/>
            <p:cNvSpPr/>
            <p:nvPr/>
          </p:nvSpPr>
          <p:spPr>
            <a:xfrm flipH="1">
              <a:off x="3875040" y="6618240"/>
              <a:ext cx="5544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"/>
            <p:cNvSpPr/>
            <p:nvPr/>
          </p:nvSpPr>
          <p:spPr>
            <a:xfrm>
              <a:off x="3996000" y="6556320"/>
              <a:ext cx="1931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519.1_R.verecundus_Papua_New_Guine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"/>
            <p:cNvSpPr/>
            <p:nvPr/>
          </p:nvSpPr>
          <p:spPr>
            <a:xfrm flipH="1">
              <a:off x="4098600" y="6683400"/>
              <a:ext cx="11124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"/>
            <p:cNvSpPr/>
            <p:nvPr/>
          </p:nvSpPr>
          <p:spPr>
            <a:xfrm>
              <a:off x="4276800" y="6621480"/>
              <a:ext cx="1931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521.1_R.verecundus_Papua_New_Guine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"/>
            <p:cNvSpPr/>
            <p:nvPr/>
          </p:nvSpPr>
          <p:spPr>
            <a:xfrm flipH="1">
              <a:off x="4098600" y="6750000"/>
              <a:ext cx="16812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"/>
            <p:cNvSpPr/>
            <p:nvPr/>
          </p:nvSpPr>
          <p:spPr>
            <a:xfrm>
              <a:off x="4334040" y="6686640"/>
              <a:ext cx="1931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522.1_R.verecundus_Papua_New_Guine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"/>
            <p:cNvSpPr/>
            <p:nvPr/>
          </p:nvSpPr>
          <p:spPr>
            <a:xfrm flipH="1">
              <a:off x="3875040" y="6716880"/>
              <a:ext cx="22392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"/>
            <p:cNvSpPr/>
            <p:nvPr/>
          </p:nvSpPr>
          <p:spPr>
            <a:xfrm>
              <a:off x="4098960" y="6683400"/>
              <a:ext cx="0" cy="6660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5" name=""/>
            <p:cNvSpPr/>
            <p:nvPr/>
          </p:nvSpPr>
          <p:spPr>
            <a:xfrm flipH="1">
              <a:off x="3484080" y="6600960"/>
              <a:ext cx="3906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"/>
            <p:cNvSpPr/>
            <p:nvPr/>
          </p:nvSpPr>
          <p:spPr>
            <a:xfrm>
              <a:off x="3875040" y="6488280"/>
              <a:ext cx="0" cy="22860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7" name=""/>
            <p:cNvSpPr/>
            <p:nvPr/>
          </p:nvSpPr>
          <p:spPr>
            <a:xfrm flipH="1">
              <a:off x="2577960" y="6459480"/>
              <a:ext cx="90648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"/>
            <p:cNvSpPr/>
            <p:nvPr/>
          </p:nvSpPr>
          <p:spPr>
            <a:xfrm>
              <a:off x="3484440" y="6319800"/>
              <a:ext cx="0" cy="28116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"/>
            <p:cNvSpPr/>
            <p:nvPr/>
          </p:nvSpPr>
          <p:spPr>
            <a:xfrm flipH="1">
              <a:off x="3900240" y="6816600"/>
              <a:ext cx="60948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"/>
            <p:cNvSpPr/>
            <p:nvPr/>
          </p:nvSpPr>
          <p:spPr>
            <a:xfrm>
              <a:off x="4573440" y="6754680"/>
              <a:ext cx="16923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58.1_R.niobe_Papua_New_Guine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"/>
            <p:cNvSpPr/>
            <p:nvPr/>
          </p:nvSpPr>
          <p:spPr>
            <a:xfrm flipH="1">
              <a:off x="4341960" y="6881760"/>
              <a:ext cx="6984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"/>
            <p:cNvSpPr/>
            <p:nvPr/>
          </p:nvSpPr>
          <p:spPr>
            <a:xfrm>
              <a:off x="4476240" y="6819840"/>
              <a:ext cx="16833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83.1_R.steini_Papua_New_Guine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"/>
            <p:cNvSpPr/>
            <p:nvPr/>
          </p:nvSpPr>
          <p:spPr>
            <a:xfrm flipH="1">
              <a:off x="4743360" y="6948360"/>
              <a:ext cx="540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"/>
            <p:cNvSpPr/>
            <p:nvPr/>
          </p:nvSpPr>
          <p:spPr>
            <a:xfrm>
              <a:off x="4863240" y="6886440"/>
              <a:ext cx="17258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54.1_R.novaeguineae_New_Guine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"/>
            <p:cNvSpPr/>
            <p:nvPr/>
          </p:nvSpPr>
          <p:spPr>
            <a:xfrm flipH="1">
              <a:off x="4743000" y="7015320"/>
              <a:ext cx="1098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"/>
            <p:cNvSpPr/>
            <p:nvPr/>
          </p:nvSpPr>
          <p:spPr>
            <a:xfrm>
              <a:off x="4914360" y="6953400"/>
              <a:ext cx="1672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56.1_R.niobe_Papua_New_guine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"/>
            <p:cNvSpPr/>
            <p:nvPr/>
          </p:nvSpPr>
          <p:spPr>
            <a:xfrm flipH="1">
              <a:off x="4743000" y="7080120"/>
              <a:ext cx="2127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"/>
            <p:cNvSpPr/>
            <p:nvPr/>
          </p:nvSpPr>
          <p:spPr>
            <a:xfrm>
              <a:off x="5021640" y="7018200"/>
              <a:ext cx="17550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63.1_R.praetor_Papua_New_Guine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"/>
            <p:cNvSpPr/>
            <p:nvPr/>
          </p:nvSpPr>
          <p:spPr>
            <a:xfrm flipH="1">
              <a:off x="4743000" y="7147080"/>
              <a:ext cx="11124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"/>
            <p:cNvSpPr/>
            <p:nvPr/>
          </p:nvSpPr>
          <p:spPr>
            <a:xfrm>
              <a:off x="4917600" y="7085160"/>
              <a:ext cx="16833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88.1_R.steini_Papua_New_Guine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"/>
            <p:cNvSpPr/>
            <p:nvPr/>
          </p:nvSpPr>
          <p:spPr>
            <a:xfrm flipH="1">
              <a:off x="4964040" y="7210440"/>
              <a:ext cx="10944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"/>
            <p:cNvSpPr/>
            <p:nvPr/>
          </p:nvSpPr>
          <p:spPr>
            <a:xfrm>
              <a:off x="5139720" y="7149960"/>
              <a:ext cx="1750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53.1_R.mordax_Papua_New_guine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"/>
            <p:cNvSpPr/>
            <p:nvPr/>
          </p:nvSpPr>
          <p:spPr>
            <a:xfrm flipH="1">
              <a:off x="4964040" y="7278840"/>
              <a:ext cx="540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"/>
            <p:cNvSpPr/>
            <p:nvPr/>
          </p:nvSpPr>
          <p:spPr>
            <a:xfrm>
              <a:off x="5086080" y="7215120"/>
              <a:ext cx="16833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87.1_R.steini_Papua_New_Guine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"/>
            <p:cNvSpPr/>
            <p:nvPr/>
          </p:nvSpPr>
          <p:spPr>
            <a:xfrm flipH="1">
              <a:off x="4743000" y="7243920"/>
              <a:ext cx="22068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"/>
            <p:cNvSpPr/>
            <p:nvPr/>
          </p:nvSpPr>
          <p:spPr>
            <a:xfrm>
              <a:off x="4964040" y="7210440"/>
              <a:ext cx="0" cy="6840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"/>
            <p:cNvSpPr/>
            <p:nvPr/>
          </p:nvSpPr>
          <p:spPr>
            <a:xfrm flipH="1">
              <a:off x="4856040" y="7345440"/>
              <a:ext cx="5904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"/>
            <p:cNvSpPr/>
            <p:nvPr/>
          </p:nvSpPr>
          <p:spPr>
            <a:xfrm>
              <a:off x="4979880" y="7283520"/>
              <a:ext cx="16923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55.1_R.niobe_Papua_New_Guine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"/>
            <p:cNvSpPr/>
            <p:nvPr/>
          </p:nvSpPr>
          <p:spPr>
            <a:xfrm flipH="1">
              <a:off x="4964040" y="7408800"/>
              <a:ext cx="540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"/>
            <p:cNvSpPr/>
            <p:nvPr/>
          </p:nvSpPr>
          <p:spPr>
            <a:xfrm>
              <a:off x="5087880" y="7348680"/>
              <a:ext cx="168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76.1_R.ruber_Papua_New_Guine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"/>
            <p:cNvSpPr/>
            <p:nvPr/>
          </p:nvSpPr>
          <p:spPr>
            <a:xfrm flipH="1">
              <a:off x="4964040" y="7477200"/>
              <a:ext cx="540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"/>
            <p:cNvSpPr/>
            <p:nvPr/>
          </p:nvSpPr>
          <p:spPr>
            <a:xfrm>
              <a:off x="5086080" y="7413480"/>
              <a:ext cx="16833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85.1_R.steini_Papua_New_Guine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"/>
            <p:cNvSpPr/>
            <p:nvPr/>
          </p:nvSpPr>
          <p:spPr>
            <a:xfrm flipH="1">
              <a:off x="4856040" y="7442280"/>
              <a:ext cx="1080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"/>
            <p:cNvSpPr/>
            <p:nvPr/>
          </p:nvSpPr>
          <p:spPr>
            <a:xfrm>
              <a:off x="4964040" y="7408800"/>
              <a:ext cx="0" cy="6840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"/>
            <p:cNvSpPr/>
            <p:nvPr/>
          </p:nvSpPr>
          <p:spPr>
            <a:xfrm flipH="1">
              <a:off x="4743000" y="7394400"/>
              <a:ext cx="11268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"/>
            <p:cNvSpPr/>
            <p:nvPr/>
          </p:nvSpPr>
          <p:spPr>
            <a:xfrm>
              <a:off x="4856040" y="7345440"/>
              <a:ext cx="0" cy="9684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"/>
            <p:cNvSpPr/>
            <p:nvPr/>
          </p:nvSpPr>
          <p:spPr>
            <a:xfrm flipH="1">
              <a:off x="4627440" y="7169040"/>
              <a:ext cx="11592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8" name=""/>
            <p:cNvSpPr/>
            <p:nvPr/>
          </p:nvSpPr>
          <p:spPr>
            <a:xfrm>
              <a:off x="4743360" y="6948360"/>
              <a:ext cx="0" cy="44604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"/>
            <p:cNvSpPr/>
            <p:nvPr/>
          </p:nvSpPr>
          <p:spPr>
            <a:xfrm flipH="1">
              <a:off x="4749840" y="7542360"/>
              <a:ext cx="5544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"/>
            <p:cNvSpPr/>
            <p:nvPr/>
          </p:nvSpPr>
          <p:spPr>
            <a:xfrm>
              <a:off x="4870800" y="7480440"/>
              <a:ext cx="17550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64.1_R.praetor_Papua_New_Guine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"/>
            <p:cNvSpPr/>
            <p:nvPr/>
          </p:nvSpPr>
          <p:spPr>
            <a:xfrm flipH="1">
              <a:off x="4749840" y="7607160"/>
              <a:ext cx="5544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"/>
            <p:cNvSpPr/>
            <p:nvPr/>
          </p:nvSpPr>
          <p:spPr>
            <a:xfrm>
              <a:off x="4870800" y="7547040"/>
              <a:ext cx="17550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66.1_R.praetor_Papua_New_Guine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"/>
            <p:cNvSpPr/>
            <p:nvPr/>
          </p:nvSpPr>
          <p:spPr>
            <a:xfrm flipH="1">
              <a:off x="4749480" y="7675560"/>
              <a:ext cx="1062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"/>
            <p:cNvSpPr/>
            <p:nvPr/>
          </p:nvSpPr>
          <p:spPr>
            <a:xfrm>
              <a:off x="4921560" y="7612200"/>
              <a:ext cx="17550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68.1_R.praetor_Papua_New_Guine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5" name=""/>
            <p:cNvSpPr/>
            <p:nvPr/>
          </p:nvSpPr>
          <p:spPr>
            <a:xfrm flipH="1">
              <a:off x="4908600" y="7738920"/>
              <a:ext cx="1029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"/>
            <p:cNvSpPr/>
            <p:nvPr/>
          </p:nvSpPr>
          <p:spPr>
            <a:xfrm>
              <a:off x="5076000" y="7678800"/>
              <a:ext cx="1252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81.1_R.steini_Indonesi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"/>
            <p:cNvSpPr/>
            <p:nvPr/>
          </p:nvSpPr>
          <p:spPr>
            <a:xfrm flipH="1">
              <a:off x="4908240" y="7805880"/>
              <a:ext cx="5724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"/>
            <p:cNvSpPr/>
            <p:nvPr/>
          </p:nvSpPr>
          <p:spPr>
            <a:xfrm>
              <a:off x="5030280" y="7743960"/>
              <a:ext cx="1252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82.1_R.steini_Indonesi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"/>
            <p:cNvSpPr/>
            <p:nvPr/>
          </p:nvSpPr>
          <p:spPr>
            <a:xfrm flipH="1">
              <a:off x="4749480" y="7772400"/>
              <a:ext cx="1587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"/>
            <p:cNvSpPr/>
            <p:nvPr/>
          </p:nvSpPr>
          <p:spPr>
            <a:xfrm>
              <a:off x="4908600" y="7738920"/>
              <a:ext cx="0" cy="6696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1" name=""/>
            <p:cNvSpPr/>
            <p:nvPr/>
          </p:nvSpPr>
          <p:spPr>
            <a:xfrm flipH="1">
              <a:off x="4627440" y="7656480"/>
              <a:ext cx="1224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"/>
            <p:cNvSpPr/>
            <p:nvPr/>
          </p:nvSpPr>
          <p:spPr>
            <a:xfrm>
              <a:off x="4749840" y="7542360"/>
              <a:ext cx="0" cy="23004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"/>
            <p:cNvSpPr/>
            <p:nvPr/>
          </p:nvSpPr>
          <p:spPr>
            <a:xfrm flipH="1">
              <a:off x="4456080" y="7412040"/>
              <a:ext cx="1713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4" name=""/>
            <p:cNvSpPr/>
            <p:nvPr/>
          </p:nvSpPr>
          <p:spPr>
            <a:xfrm>
              <a:off x="4627440" y="7169040"/>
              <a:ext cx="0" cy="48744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5" name=""/>
            <p:cNvSpPr/>
            <p:nvPr/>
          </p:nvSpPr>
          <p:spPr>
            <a:xfrm flipH="1">
              <a:off x="4568760" y="7873920"/>
              <a:ext cx="525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6" name=""/>
            <p:cNvSpPr/>
            <p:nvPr/>
          </p:nvSpPr>
          <p:spPr>
            <a:xfrm>
              <a:off x="4688280" y="7810560"/>
              <a:ext cx="17550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65.1_R.praetor_Papua_New_Guine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7" name=""/>
            <p:cNvSpPr/>
            <p:nvPr/>
          </p:nvSpPr>
          <p:spPr>
            <a:xfrm flipH="1">
              <a:off x="4568760" y="7937640"/>
              <a:ext cx="525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8" name=""/>
            <p:cNvSpPr/>
            <p:nvPr/>
          </p:nvSpPr>
          <p:spPr>
            <a:xfrm>
              <a:off x="4688280" y="7877160"/>
              <a:ext cx="17550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67.1_R.praetor_Papua_New_Guine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9" name=""/>
            <p:cNvSpPr/>
            <p:nvPr/>
          </p:nvSpPr>
          <p:spPr>
            <a:xfrm flipH="1">
              <a:off x="4568760" y="8004240"/>
              <a:ext cx="525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0" name=""/>
            <p:cNvSpPr/>
            <p:nvPr/>
          </p:nvSpPr>
          <p:spPr>
            <a:xfrm>
              <a:off x="4685760" y="7942320"/>
              <a:ext cx="16833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86.1_R.steini_Papua_New_Guine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1" name=""/>
            <p:cNvSpPr/>
            <p:nvPr/>
          </p:nvSpPr>
          <p:spPr>
            <a:xfrm flipH="1">
              <a:off x="4568760" y="8070840"/>
              <a:ext cx="525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2" name=""/>
            <p:cNvSpPr/>
            <p:nvPr/>
          </p:nvSpPr>
          <p:spPr>
            <a:xfrm>
              <a:off x="4685760" y="8007480"/>
              <a:ext cx="16833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89.1_R.steini_Papua_New_Guine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3" name=""/>
            <p:cNvSpPr/>
            <p:nvPr/>
          </p:nvSpPr>
          <p:spPr>
            <a:xfrm flipH="1">
              <a:off x="4455720" y="7970760"/>
              <a:ext cx="11268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4" name=""/>
            <p:cNvSpPr/>
            <p:nvPr/>
          </p:nvSpPr>
          <p:spPr>
            <a:xfrm>
              <a:off x="4568760" y="7873920"/>
              <a:ext cx="0" cy="19692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5" name=""/>
            <p:cNvSpPr/>
            <p:nvPr/>
          </p:nvSpPr>
          <p:spPr>
            <a:xfrm flipH="1">
              <a:off x="4341600" y="7691400"/>
              <a:ext cx="11412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6" name=""/>
            <p:cNvSpPr/>
            <p:nvPr/>
          </p:nvSpPr>
          <p:spPr>
            <a:xfrm>
              <a:off x="4456080" y="7412040"/>
              <a:ext cx="0" cy="55872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7" name=""/>
            <p:cNvSpPr/>
            <p:nvPr/>
          </p:nvSpPr>
          <p:spPr>
            <a:xfrm flipH="1">
              <a:off x="3900600" y="7284960"/>
              <a:ext cx="4413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8" name=""/>
            <p:cNvSpPr/>
            <p:nvPr/>
          </p:nvSpPr>
          <p:spPr>
            <a:xfrm>
              <a:off x="4341960" y="6881760"/>
              <a:ext cx="0" cy="80964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9" name=""/>
            <p:cNvSpPr/>
            <p:nvPr/>
          </p:nvSpPr>
          <p:spPr>
            <a:xfrm flipH="1">
              <a:off x="2903400" y="7050240"/>
              <a:ext cx="9972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0" name=""/>
            <p:cNvSpPr/>
            <p:nvPr/>
          </p:nvSpPr>
          <p:spPr>
            <a:xfrm>
              <a:off x="3900600" y="6816600"/>
              <a:ext cx="0" cy="46836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1" name=""/>
            <p:cNvSpPr/>
            <p:nvPr/>
          </p:nvSpPr>
          <p:spPr>
            <a:xfrm flipH="1">
              <a:off x="3330720" y="8136000"/>
              <a:ext cx="4413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2" name=""/>
            <p:cNvSpPr/>
            <p:nvPr/>
          </p:nvSpPr>
          <p:spPr>
            <a:xfrm>
              <a:off x="3836880" y="8075520"/>
              <a:ext cx="16923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59.1_R.niobe_Papua_New_Guine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3" name=""/>
            <p:cNvSpPr/>
            <p:nvPr/>
          </p:nvSpPr>
          <p:spPr>
            <a:xfrm flipH="1">
              <a:off x="3330360" y="8202600"/>
              <a:ext cx="7887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4" name=""/>
            <p:cNvSpPr/>
            <p:nvPr/>
          </p:nvSpPr>
          <p:spPr>
            <a:xfrm>
              <a:off x="4184640" y="8140680"/>
              <a:ext cx="16923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60.1_R.niobe_Papua_New_Guine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5" name=""/>
            <p:cNvSpPr/>
            <p:nvPr/>
          </p:nvSpPr>
          <p:spPr>
            <a:xfrm flipH="1">
              <a:off x="3330720" y="8269200"/>
              <a:ext cx="52704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6" name=""/>
            <p:cNvSpPr/>
            <p:nvPr/>
          </p:nvSpPr>
          <p:spPr>
            <a:xfrm>
              <a:off x="3924360" y="8205840"/>
              <a:ext cx="1931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520.1_R.verecundus_Papua_New_Guine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7" name=""/>
            <p:cNvSpPr/>
            <p:nvPr/>
          </p:nvSpPr>
          <p:spPr>
            <a:xfrm flipH="1">
              <a:off x="2903040" y="8201160"/>
              <a:ext cx="42732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8" name=""/>
            <p:cNvSpPr/>
            <p:nvPr/>
          </p:nvSpPr>
          <p:spPr>
            <a:xfrm>
              <a:off x="3330720" y="8136000"/>
              <a:ext cx="0" cy="13320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9" name=""/>
            <p:cNvSpPr/>
            <p:nvPr/>
          </p:nvSpPr>
          <p:spPr>
            <a:xfrm flipH="1">
              <a:off x="2577960" y="7626240"/>
              <a:ext cx="32544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0" name=""/>
            <p:cNvSpPr/>
            <p:nvPr/>
          </p:nvSpPr>
          <p:spPr>
            <a:xfrm>
              <a:off x="2903400" y="7050240"/>
              <a:ext cx="0" cy="115092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1" name=""/>
            <p:cNvSpPr/>
            <p:nvPr/>
          </p:nvSpPr>
          <p:spPr>
            <a:xfrm flipH="1">
              <a:off x="3857760" y="8334360"/>
              <a:ext cx="4608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2" name=""/>
            <p:cNvSpPr/>
            <p:nvPr/>
          </p:nvSpPr>
          <p:spPr>
            <a:xfrm>
              <a:off x="3973320" y="8273880"/>
              <a:ext cx="16970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71.1_R.rattus_Papua_New_Guine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3" name=""/>
            <p:cNvSpPr/>
            <p:nvPr/>
          </p:nvSpPr>
          <p:spPr>
            <a:xfrm flipH="1">
              <a:off x="3857760" y="8400960"/>
              <a:ext cx="4608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4" name=""/>
            <p:cNvSpPr/>
            <p:nvPr/>
          </p:nvSpPr>
          <p:spPr>
            <a:xfrm>
              <a:off x="3973320" y="8339040"/>
              <a:ext cx="16970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73.1_R.rattus_Papua_New_Guine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5" name=""/>
            <p:cNvSpPr/>
            <p:nvPr/>
          </p:nvSpPr>
          <p:spPr>
            <a:xfrm flipH="1">
              <a:off x="3217680" y="8367840"/>
              <a:ext cx="63972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6" name=""/>
            <p:cNvSpPr/>
            <p:nvPr/>
          </p:nvSpPr>
          <p:spPr>
            <a:xfrm>
              <a:off x="3857760" y="8334360"/>
              <a:ext cx="0" cy="6660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7" name=""/>
            <p:cNvSpPr/>
            <p:nvPr/>
          </p:nvSpPr>
          <p:spPr>
            <a:xfrm flipH="1">
              <a:off x="3690720" y="8466120"/>
              <a:ext cx="16668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8" name=""/>
            <p:cNvSpPr/>
            <p:nvPr/>
          </p:nvSpPr>
          <p:spPr>
            <a:xfrm>
              <a:off x="3922200" y="8404200"/>
              <a:ext cx="1340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77.1_R.sordidus_Australi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9" name=""/>
            <p:cNvSpPr/>
            <p:nvPr/>
          </p:nvSpPr>
          <p:spPr>
            <a:xfrm flipH="1">
              <a:off x="3691080" y="8532720"/>
              <a:ext cx="2109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0" name=""/>
            <p:cNvSpPr/>
            <p:nvPr/>
          </p:nvSpPr>
          <p:spPr>
            <a:xfrm>
              <a:off x="3966840" y="8469360"/>
              <a:ext cx="1340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78.1_R.sordidus_Australi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1" name=""/>
            <p:cNvSpPr/>
            <p:nvPr/>
          </p:nvSpPr>
          <p:spPr>
            <a:xfrm flipH="1">
              <a:off x="3794040" y="8597880"/>
              <a:ext cx="540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2" name=""/>
            <p:cNvSpPr/>
            <p:nvPr/>
          </p:nvSpPr>
          <p:spPr>
            <a:xfrm>
              <a:off x="3912840" y="8535960"/>
              <a:ext cx="1340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79.1_R.sordidus_Australi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3" name=""/>
            <p:cNvSpPr/>
            <p:nvPr/>
          </p:nvSpPr>
          <p:spPr>
            <a:xfrm flipH="1">
              <a:off x="3793680" y="8664480"/>
              <a:ext cx="4788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4" name=""/>
            <p:cNvSpPr/>
            <p:nvPr/>
          </p:nvSpPr>
          <p:spPr>
            <a:xfrm>
              <a:off x="3906360" y="8602560"/>
              <a:ext cx="1340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480.1_R.sordidus_Australi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5" name=""/>
            <p:cNvSpPr/>
            <p:nvPr/>
          </p:nvSpPr>
          <p:spPr>
            <a:xfrm flipH="1">
              <a:off x="3691080" y="8631360"/>
              <a:ext cx="1029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6" name=""/>
            <p:cNvSpPr/>
            <p:nvPr/>
          </p:nvSpPr>
          <p:spPr>
            <a:xfrm>
              <a:off x="3794040" y="8597880"/>
              <a:ext cx="0" cy="6660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7" name=""/>
            <p:cNvSpPr/>
            <p:nvPr/>
          </p:nvSpPr>
          <p:spPr>
            <a:xfrm flipH="1">
              <a:off x="3218040" y="8548560"/>
              <a:ext cx="47304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8" name=""/>
            <p:cNvSpPr/>
            <p:nvPr/>
          </p:nvSpPr>
          <p:spPr>
            <a:xfrm>
              <a:off x="3691080" y="8466120"/>
              <a:ext cx="0" cy="16524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9" name=""/>
            <p:cNvSpPr/>
            <p:nvPr/>
          </p:nvSpPr>
          <p:spPr>
            <a:xfrm flipH="1">
              <a:off x="2577960" y="8458200"/>
              <a:ext cx="64008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0" name=""/>
            <p:cNvSpPr/>
            <p:nvPr/>
          </p:nvSpPr>
          <p:spPr>
            <a:xfrm>
              <a:off x="3218040" y="8367840"/>
              <a:ext cx="0" cy="18072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1" name=""/>
            <p:cNvSpPr/>
            <p:nvPr/>
          </p:nvSpPr>
          <p:spPr>
            <a:xfrm flipH="1">
              <a:off x="2090520" y="7232760"/>
              <a:ext cx="48708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2" name=""/>
            <p:cNvSpPr/>
            <p:nvPr/>
          </p:nvSpPr>
          <p:spPr>
            <a:xfrm>
              <a:off x="2577960" y="6006960"/>
              <a:ext cx="0" cy="245124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3" name=""/>
            <p:cNvSpPr/>
            <p:nvPr/>
          </p:nvSpPr>
          <p:spPr>
            <a:xfrm flipH="1">
              <a:off x="3215880" y="8731080"/>
              <a:ext cx="26820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4" name=""/>
            <p:cNvSpPr/>
            <p:nvPr/>
          </p:nvSpPr>
          <p:spPr>
            <a:xfrm>
              <a:off x="3548880" y="8669160"/>
              <a:ext cx="12916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518.1_R.tunneyi_Australi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5" name=""/>
            <p:cNvSpPr/>
            <p:nvPr/>
          </p:nvSpPr>
          <p:spPr>
            <a:xfrm flipH="1">
              <a:off x="3551400" y="8796240"/>
              <a:ext cx="25848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6" name=""/>
            <p:cNvSpPr/>
            <p:nvPr/>
          </p:nvSpPr>
          <p:spPr>
            <a:xfrm>
              <a:off x="3874320" y="8734320"/>
              <a:ext cx="12916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516.1_R.tunneyi_Australi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7" name=""/>
            <p:cNvSpPr/>
            <p:nvPr/>
          </p:nvSpPr>
          <p:spPr>
            <a:xfrm flipH="1">
              <a:off x="3720960" y="8862840"/>
              <a:ext cx="26208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8" name=""/>
            <p:cNvSpPr/>
            <p:nvPr/>
          </p:nvSpPr>
          <p:spPr>
            <a:xfrm>
              <a:off x="4046040" y="8801280"/>
              <a:ext cx="12916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515.1_R.tunneyi_Australi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9" name=""/>
            <p:cNvSpPr/>
            <p:nvPr/>
          </p:nvSpPr>
          <p:spPr>
            <a:xfrm flipH="1">
              <a:off x="3720600" y="8929800"/>
              <a:ext cx="5223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0" name=""/>
            <p:cNvSpPr/>
            <p:nvPr/>
          </p:nvSpPr>
          <p:spPr>
            <a:xfrm>
              <a:off x="4309560" y="8867880"/>
              <a:ext cx="12916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F186517.1_R.tunneyi_Australi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1" name=""/>
            <p:cNvSpPr/>
            <p:nvPr/>
          </p:nvSpPr>
          <p:spPr>
            <a:xfrm flipH="1">
              <a:off x="3551040" y="8896320"/>
              <a:ext cx="1695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2" name=""/>
            <p:cNvSpPr/>
            <p:nvPr/>
          </p:nvSpPr>
          <p:spPr>
            <a:xfrm>
              <a:off x="3720960" y="8862840"/>
              <a:ext cx="0" cy="6696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3" name=""/>
            <p:cNvSpPr/>
            <p:nvPr/>
          </p:nvSpPr>
          <p:spPr>
            <a:xfrm flipH="1">
              <a:off x="3215880" y="8845560"/>
              <a:ext cx="3351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4" name=""/>
            <p:cNvSpPr/>
            <p:nvPr/>
          </p:nvSpPr>
          <p:spPr>
            <a:xfrm>
              <a:off x="3551400" y="8796240"/>
              <a:ext cx="0" cy="10008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5" name=""/>
            <p:cNvSpPr/>
            <p:nvPr/>
          </p:nvSpPr>
          <p:spPr>
            <a:xfrm flipH="1">
              <a:off x="2090880" y="8788320"/>
              <a:ext cx="11253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6" name=""/>
            <p:cNvSpPr/>
            <p:nvPr/>
          </p:nvSpPr>
          <p:spPr>
            <a:xfrm>
              <a:off x="3216240" y="8731080"/>
              <a:ext cx="0" cy="11448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7" name=""/>
            <p:cNvSpPr/>
            <p:nvPr/>
          </p:nvSpPr>
          <p:spPr>
            <a:xfrm flipH="1">
              <a:off x="1044720" y="8008920"/>
              <a:ext cx="104616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8" name=""/>
            <p:cNvSpPr/>
            <p:nvPr/>
          </p:nvSpPr>
          <p:spPr>
            <a:xfrm>
              <a:off x="2090880" y="7232760"/>
              <a:ext cx="0" cy="155556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9" name=""/>
            <p:cNvSpPr/>
            <p:nvPr/>
          </p:nvSpPr>
          <p:spPr>
            <a:xfrm flipH="1">
              <a:off x="30240" y="5994360"/>
              <a:ext cx="1014480" cy="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0" name=""/>
            <p:cNvSpPr/>
            <p:nvPr/>
          </p:nvSpPr>
          <p:spPr>
            <a:xfrm>
              <a:off x="1044720" y="3983040"/>
              <a:ext cx="0" cy="402588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1" name=""/>
            <p:cNvSpPr/>
            <p:nvPr/>
          </p:nvSpPr>
          <p:spPr>
            <a:xfrm>
              <a:off x="31680" y="87480"/>
              <a:ext cx="0" cy="590868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42" name=""/>
          <p:cNvSpPr/>
          <p:nvPr/>
        </p:nvSpPr>
        <p:spPr>
          <a:xfrm>
            <a:off x="4114800" y="228600"/>
            <a:ext cx="274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R. norvegicus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clad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3" name=""/>
          <p:cNvSpPr/>
          <p:nvPr/>
        </p:nvSpPr>
        <p:spPr>
          <a:xfrm>
            <a:off x="5257800" y="1263600"/>
            <a:ext cx="27432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R. tanezumi</a:t>
            </a:r>
            <a:br>
              <a:rPr sz="1800"/>
            </a:b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iardii clad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4" name=""/>
          <p:cNvSpPr/>
          <p:nvPr/>
        </p:nvSpPr>
        <p:spPr>
          <a:xfrm>
            <a:off x="6172200" y="2971800"/>
            <a:ext cx="2743200" cy="41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Monospecific </a:t>
            </a:r>
            <a:br>
              <a:rPr sz="700"/>
            </a:br>
            <a:r>
              <a:rPr b="1" i="1" lang="en-US" sz="700" spc="-1" strike="noStrike">
                <a:solidFill>
                  <a:srgbClr val="000000"/>
                </a:solidFill>
                <a:latin typeface="Arial"/>
              </a:rPr>
              <a:t>tanezumi</a:t>
            </a:r>
            <a:br>
              <a:rPr sz="700"/>
            </a:b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clade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5" name=""/>
          <p:cNvSpPr/>
          <p:nvPr/>
        </p:nvSpPr>
        <p:spPr>
          <a:xfrm>
            <a:off x="6191280" y="3564000"/>
            <a:ext cx="27432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attus I</a:t>
            </a:r>
            <a:br>
              <a:rPr sz="1000"/>
            </a:b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lad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6" name=""/>
          <p:cNvSpPr/>
          <p:nvPr/>
        </p:nvSpPr>
        <p:spPr>
          <a:xfrm>
            <a:off x="5029200" y="2362320"/>
            <a:ext cx="2743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600" spc="-1" strike="noStrike">
                <a:solidFill>
                  <a:srgbClr val="000000"/>
                </a:solidFill>
                <a:latin typeface="Arial"/>
              </a:rPr>
              <a:t>tiomanicus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clad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7" name=""/>
          <p:cNvSpPr/>
          <p:nvPr/>
        </p:nvSpPr>
        <p:spPr>
          <a:xfrm flipV="1">
            <a:off x="828720" y="209520"/>
            <a:ext cx="990720" cy="5335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8" name=""/>
          <p:cNvSpPr/>
          <p:nvPr/>
        </p:nvSpPr>
        <p:spPr>
          <a:xfrm flipV="1">
            <a:off x="838080" y="276120"/>
            <a:ext cx="990720" cy="5335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9" name=""/>
          <p:cNvSpPr/>
          <p:nvPr/>
        </p:nvSpPr>
        <p:spPr>
          <a:xfrm flipV="1">
            <a:off x="2428920" y="923760"/>
            <a:ext cx="990720" cy="5335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0" name=""/>
          <p:cNvSpPr/>
          <p:nvPr/>
        </p:nvSpPr>
        <p:spPr>
          <a:xfrm flipV="1">
            <a:off x="2438280" y="1000080"/>
            <a:ext cx="990720" cy="5335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1" name=""/>
          <p:cNvSpPr/>
          <p:nvPr/>
        </p:nvSpPr>
        <p:spPr>
          <a:xfrm>
            <a:off x="66600" y="700200"/>
            <a:ext cx="3133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R. norvegicus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(RN41 &amp; 46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2" name=""/>
          <p:cNvSpPr/>
          <p:nvPr/>
        </p:nvSpPr>
        <p:spPr>
          <a:xfrm>
            <a:off x="66600" y="1415880"/>
            <a:ext cx="3429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R. Tanezumi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(RT49 &amp; 50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4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7-07T10:41:43Z</dcterms:created>
  <dc:creator>Patrik Johansson</dc:creator>
  <dc:description/>
  <dc:language>en-US</dc:language>
  <cp:lastModifiedBy>Bucht</cp:lastModifiedBy>
  <dcterms:modified xsi:type="dcterms:W3CDTF">2010-01-10T10:34:27Z</dcterms:modified>
  <cp:revision>10</cp:revision>
  <dc:subject/>
  <dc:title>Slide 1</dc:title>
</cp:coreProperties>
</file>